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8" r:id="rId2"/>
  </p:sldIdLst>
  <p:sldSz cx="9144000" cy="6858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F72C4D63-5AB8-4686-A4FD-D7F2930A7C9C}">
          <p14:sldIdLst>
            <p14:sldId id="278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909" autoAdjust="0"/>
    <p:restoredTop sz="94552" autoAdjust="0"/>
  </p:normalViewPr>
  <p:slideViewPr>
    <p:cSldViewPr snapToGrid="0">
      <p:cViewPr varScale="1">
        <p:scale>
          <a:sx n="108" d="100"/>
          <a:sy n="108" d="100"/>
        </p:scale>
        <p:origin x="2034" y="12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1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C23256D-21BC-4272-8A62-44FFD7B2F28D}" type="datetimeFigureOut">
              <a:rPr lang="en-US" smtClean="0"/>
              <a:t>11/9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49"/>
            <a:ext cx="5486400" cy="360045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6206A81-E7AA-4295-BE03-6221A7FDB4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30463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CA266-E66D-4018-A1C9-B2D871B9E5F1}" type="datetimeFigureOut">
              <a:rPr lang="en-US" smtClean="0"/>
              <a:t>11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F7ED39-37A6-4F79-9E52-7429A350E8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01119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CA266-E66D-4018-A1C9-B2D871B9E5F1}" type="datetimeFigureOut">
              <a:rPr lang="en-US" smtClean="0"/>
              <a:t>11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F7ED39-37A6-4F79-9E52-7429A350E8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85293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CA266-E66D-4018-A1C9-B2D871B9E5F1}" type="datetimeFigureOut">
              <a:rPr lang="en-US" smtClean="0"/>
              <a:t>11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F7ED39-37A6-4F79-9E52-7429A350E8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66694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CA266-E66D-4018-A1C9-B2D871B9E5F1}" type="datetimeFigureOut">
              <a:rPr lang="en-US" smtClean="0"/>
              <a:t>11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F7ED39-37A6-4F79-9E52-7429A350E8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33512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41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6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CA266-E66D-4018-A1C9-B2D871B9E5F1}" type="datetimeFigureOut">
              <a:rPr lang="en-US" smtClean="0"/>
              <a:t>11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F7ED39-37A6-4F79-9E52-7429A350E8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2674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CA266-E66D-4018-A1C9-B2D871B9E5F1}" type="datetimeFigureOut">
              <a:rPr lang="en-US" smtClean="0"/>
              <a:t>11/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F7ED39-37A6-4F79-9E52-7429A350E8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51359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8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CA266-E66D-4018-A1C9-B2D871B9E5F1}" type="datetimeFigureOut">
              <a:rPr lang="en-US" smtClean="0"/>
              <a:t>11/9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F7ED39-37A6-4F79-9E52-7429A350E8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18505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CA266-E66D-4018-A1C9-B2D871B9E5F1}" type="datetimeFigureOut">
              <a:rPr lang="en-US" smtClean="0"/>
              <a:t>11/9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F7ED39-37A6-4F79-9E52-7429A350E8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753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CA266-E66D-4018-A1C9-B2D871B9E5F1}" type="datetimeFigureOut">
              <a:rPr lang="en-US" smtClean="0"/>
              <a:t>11/9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F7ED39-37A6-4F79-9E52-7429A350E8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32730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8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CA266-E66D-4018-A1C9-B2D871B9E5F1}" type="datetimeFigureOut">
              <a:rPr lang="en-US" smtClean="0"/>
              <a:t>11/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F7ED39-37A6-4F79-9E52-7429A350E8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37645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8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CA266-E66D-4018-A1C9-B2D871B9E5F1}" type="datetimeFigureOut">
              <a:rPr lang="en-US" smtClean="0"/>
              <a:t>11/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F7ED39-37A6-4F79-9E52-7429A350E8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52768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8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3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5ACA266-E66D-4018-A1C9-B2D871B9E5F1}" type="datetimeFigureOut">
              <a:rPr lang="en-US" smtClean="0"/>
              <a:t>11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3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3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DF7ED39-37A6-4F79-9E52-7429A350E8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88541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colorful squares with black dots&#10;&#10;AI-generated content may be incorrect.">
            <a:extLst>
              <a:ext uri="{FF2B5EF4-FFF2-40B4-BE49-F238E27FC236}">
                <a16:creationId xmlns:a16="http://schemas.microsoft.com/office/drawing/2014/main" id="{62A6994C-E36A-4021-5F7A-50C8005C9E6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22954" y="1240451"/>
            <a:ext cx="1512173" cy="4504277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0FDDD03A-6C28-50ED-BD09-F48AA3C97365}"/>
              </a:ext>
            </a:extLst>
          </p:cNvPr>
          <p:cNvSpPr txBox="1"/>
          <p:nvPr/>
        </p:nvSpPr>
        <p:spPr>
          <a:xfrm>
            <a:off x="3301235" y="742658"/>
            <a:ext cx="261962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HALLMARK_INFLAMMATORY_</a:t>
            </a:r>
            <a:r>
              <a:rPr lang="en-US" sz="1000" dirty="0"/>
              <a:t>RESPONSE</a:t>
            </a:r>
          </a:p>
        </p:txBody>
      </p:sp>
      <p:pic>
        <p:nvPicPr>
          <p:cNvPr id="8" name="Picture 7" descr="A colorful squares with black dots&#10;&#10;AI-generated content may be incorrect.">
            <a:extLst>
              <a:ext uri="{FF2B5EF4-FFF2-40B4-BE49-F238E27FC236}">
                <a16:creationId xmlns:a16="http://schemas.microsoft.com/office/drawing/2014/main" id="{1536AC90-B909-3EA6-17FD-04480640BD6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00238" y="1240450"/>
            <a:ext cx="1512173" cy="4504276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0ED14227-3C19-CA1F-919C-358C8A8E62CD}"/>
              </a:ext>
            </a:extLst>
          </p:cNvPr>
          <p:cNvSpPr txBox="1"/>
          <p:nvPr/>
        </p:nvSpPr>
        <p:spPr>
          <a:xfrm>
            <a:off x="3447106" y="978840"/>
            <a:ext cx="4187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VAT</a:t>
            </a:r>
            <a:endParaRPr lang="en-US" sz="10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C5F93FD-E41F-E0E3-3EEC-1ECB37D74AFB}"/>
              </a:ext>
            </a:extLst>
          </p:cNvPr>
          <p:cNvSpPr txBox="1"/>
          <p:nvPr/>
        </p:nvSpPr>
        <p:spPr>
          <a:xfrm>
            <a:off x="5004868" y="978840"/>
            <a:ext cx="4154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SAT</a:t>
            </a:r>
            <a:endParaRPr lang="en-US" sz="1000" dirty="0"/>
          </a:p>
        </p:txBody>
      </p:sp>
      <p:pic>
        <p:nvPicPr>
          <p:cNvPr id="12" name="Picture 11" descr="A colorful squares with black and white text&#10;&#10;AI-generated content may be incorrect.">
            <a:extLst>
              <a:ext uri="{FF2B5EF4-FFF2-40B4-BE49-F238E27FC236}">
                <a16:creationId xmlns:a16="http://schemas.microsoft.com/office/drawing/2014/main" id="{061380B6-3297-53A5-A008-6D64D61A5D4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3633" y="1225009"/>
            <a:ext cx="1397212" cy="4504277"/>
          </a:xfrm>
          <a:prstGeom prst="rect">
            <a:avLst/>
          </a:prstGeom>
        </p:spPr>
      </p:pic>
      <p:pic>
        <p:nvPicPr>
          <p:cNvPr id="14" name="Picture 13" descr="A close-up of a grid&#10;&#10;AI-generated content may be incorrect.">
            <a:extLst>
              <a:ext uri="{FF2B5EF4-FFF2-40B4-BE49-F238E27FC236}">
                <a16:creationId xmlns:a16="http://schemas.microsoft.com/office/drawing/2014/main" id="{C9E2C7EB-EF5B-5421-44EA-B03FF1ACC7A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288" y="1240452"/>
            <a:ext cx="1397212" cy="4504274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47F1DC10-42DE-C7A5-9CB0-47EB0F0D2D93}"/>
              </a:ext>
            </a:extLst>
          </p:cNvPr>
          <p:cNvSpPr txBox="1"/>
          <p:nvPr/>
        </p:nvSpPr>
        <p:spPr>
          <a:xfrm>
            <a:off x="326216" y="742658"/>
            <a:ext cx="25715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HALLMARK_FATTY_ACID_METABOLISM</a:t>
            </a:r>
            <a:endParaRPr lang="en-US" sz="1000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B523DAF-009E-11BF-2024-44E813E90287}"/>
              </a:ext>
            </a:extLst>
          </p:cNvPr>
          <p:cNvSpPr txBox="1"/>
          <p:nvPr/>
        </p:nvSpPr>
        <p:spPr>
          <a:xfrm>
            <a:off x="498462" y="983551"/>
            <a:ext cx="4187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VAT</a:t>
            </a:r>
            <a:endParaRPr lang="en-US" sz="1000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87BDFE03-13FB-B685-34F5-7EC12A316264}"/>
              </a:ext>
            </a:extLst>
          </p:cNvPr>
          <p:cNvSpPr txBox="1"/>
          <p:nvPr/>
        </p:nvSpPr>
        <p:spPr>
          <a:xfrm>
            <a:off x="1887892" y="1007951"/>
            <a:ext cx="4154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SAT</a:t>
            </a:r>
            <a:endParaRPr lang="en-US" sz="1000" dirty="0"/>
          </a:p>
        </p:txBody>
      </p:sp>
      <p:pic>
        <p:nvPicPr>
          <p:cNvPr id="25" name="Picture 24" descr="A colorful squares with black and white text&#10;&#10;AI-generated content may be incorrect.">
            <a:extLst>
              <a:ext uri="{FF2B5EF4-FFF2-40B4-BE49-F238E27FC236}">
                <a16:creationId xmlns:a16="http://schemas.microsoft.com/office/drawing/2014/main" id="{38050177-9BB6-DB28-6FF3-0CCAA8ED7055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19712" y="1240450"/>
            <a:ext cx="1353969" cy="2549011"/>
          </a:xfrm>
          <a:prstGeom prst="rect">
            <a:avLst/>
          </a:prstGeom>
        </p:spPr>
      </p:pic>
      <p:pic>
        <p:nvPicPr>
          <p:cNvPr id="27" name="Picture 26" descr="A colorful squares with black and orange squares&#10;&#10;AI-generated content may be incorrect.">
            <a:extLst>
              <a:ext uri="{FF2B5EF4-FFF2-40B4-BE49-F238E27FC236}">
                <a16:creationId xmlns:a16="http://schemas.microsoft.com/office/drawing/2014/main" id="{94C1096A-96CE-0EBD-D608-08BC87CC1EE9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55205" y="1251464"/>
            <a:ext cx="1488595" cy="2549013"/>
          </a:xfrm>
          <a:prstGeom prst="rect">
            <a:avLst/>
          </a:prstGeom>
        </p:spPr>
      </p:pic>
      <p:sp>
        <p:nvSpPr>
          <p:cNvPr id="28" name="TextBox 27">
            <a:extLst>
              <a:ext uri="{FF2B5EF4-FFF2-40B4-BE49-F238E27FC236}">
                <a16:creationId xmlns:a16="http://schemas.microsoft.com/office/drawing/2014/main" id="{C99B8EFE-BCE3-3AEE-2397-406FDC9B3FCF}"/>
              </a:ext>
            </a:extLst>
          </p:cNvPr>
          <p:cNvSpPr txBox="1"/>
          <p:nvPr/>
        </p:nvSpPr>
        <p:spPr>
          <a:xfrm>
            <a:off x="6246248" y="746341"/>
            <a:ext cx="2553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KEGG_ECM_RECEPTOR_INTERACTION</a:t>
            </a:r>
            <a:endParaRPr lang="en-US" sz="1000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C9E5DF71-8769-1778-7EB0-A7A21F7F5DE8}"/>
              </a:ext>
            </a:extLst>
          </p:cNvPr>
          <p:cNvSpPr txBox="1"/>
          <p:nvPr/>
        </p:nvSpPr>
        <p:spPr>
          <a:xfrm>
            <a:off x="6467280" y="1008891"/>
            <a:ext cx="4187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VAT</a:t>
            </a:r>
            <a:endParaRPr lang="en-US" sz="1000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C92A9F2A-DE71-BA92-CF13-4A0A7CEC4E82}"/>
              </a:ext>
            </a:extLst>
          </p:cNvPr>
          <p:cNvSpPr txBox="1"/>
          <p:nvPr/>
        </p:nvSpPr>
        <p:spPr>
          <a:xfrm>
            <a:off x="8035305" y="978840"/>
            <a:ext cx="4154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SAT</a:t>
            </a:r>
            <a:endParaRPr lang="en-US" sz="1000" dirty="0"/>
          </a:p>
        </p:txBody>
      </p:sp>
      <p:pic>
        <p:nvPicPr>
          <p:cNvPr id="31" name="Picture 30" descr="A close-up of a colorful pattern&#10;&#10;AI-generated content may be incorrect.">
            <a:extLst>
              <a:ext uri="{FF2B5EF4-FFF2-40B4-BE49-F238E27FC236}">
                <a16:creationId xmlns:a16="http://schemas.microsoft.com/office/drawing/2014/main" id="{A7ED283E-7EAE-798E-71B3-5594976EDA4F}"/>
              </a:ext>
            </a:extLst>
          </p:cNvPr>
          <p:cNvPicPr>
            <a:picLocks noChangeAspect="1"/>
          </p:cNvPicPr>
          <p:nvPr/>
        </p:nvPicPr>
        <p:blipFill>
          <a:blip r:embed="rId8"/>
          <a:srcRect l="86111" b="71296"/>
          <a:stretch>
            <a:fillRect/>
          </a:stretch>
        </p:blipFill>
        <p:spPr>
          <a:xfrm>
            <a:off x="7178607" y="3917577"/>
            <a:ext cx="689185" cy="1827149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94137479-EF58-3289-B199-9D7BFBBB442C}"/>
              </a:ext>
            </a:extLst>
          </p:cNvPr>
          <p:cNvSpPr txBox="1"/>
          <p:nvPr/>
        </p:nvSpPr>
        <p:spPr>
          <a:xfrm>
            <a:off x="326216" y="270951"/>
            <a:ext cx="5310203" cy="2509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Bef>
                <a:spcPts val="600"/>
              </a:spcBef>
              <a:spcAft>
                <a:spcPts val="300"/>
              </a:spcAft>
            </a:pPr>
            <a:r>
              <a:rPr lang="en-US" sz="1000" b="1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upplementary </a:t>
            </a:r>
            <a:r>
              <a:rPr lang="en-US" sz="1000" b="1" kern="10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Figure S2</a:t>
            </a:r>
            <a:r>
              <a:rPr lang="en-US" sz="10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: Leading edge gene heatmaps for select </a:t>
            </a:r>
            <a:r>
              <a:rPr lang="en-US" sz="1000" kern="100" dirty="0"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differentially regulated </a:t>
            </a:r>
            <a:r>
              <a:rPr lang="en-US" sz="1000" kern="10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gene sets </a:t>
            </a:r>
            <a:endParaRPr lang="en-US" sz="10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303046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03</TotalTime>
  <Words>39</Words>
  <Application>Microsoft Office PowerPoint</Application>
  <PresentationFormat>Letter Paper (8.5x11 in)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'Rourke, Robert</dc:creator>
  <cp:lastModifiedBy>MDPI</cp:lastModifiedBy>
  <cp:revision>120</cp:revision>
  <dcterms:created xsi:type="dcterms:W3CDTF">2024-08-06T14:41:35Z</dcterms:created>
  <dcterms:modified xsi:type="dcterms:W3CDTF">2025-11-09T06:44:39Z</dcterms:modified>
</cp:coreProperties>
</file>